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AB2641-376C-4876-8EC4-F53ADD179DF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E423A6-0FB6-4D1A-B532-7609C53FAFA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8F2F1E-8833-4632-A23A-C371213FDEE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C73ABF-1B72-4A5B-9FAF-633F25DFDF4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959B6A-4E62-4745-AC89-94DFB236A90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090E7B-9BD7-4154-9351-0AD933FB311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5950B4-6647-4B5B-B744-A87B2D3EB91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28320C-D178-4A51-939A-6B183C131F2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DBA098-BFF7-4029-B35A-40809ADABD0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CF8B1D-1C8D-4652-A269-740F518261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477E6D-ACA4-4AF9-B24F-90A118FA17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B88B33-1038-499E-B290-BCAE2C4538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19800"/>
            <a:ext cx="1600200" cy="68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19800"/>
            <a:ext cx="2171520" cy="68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19800"/>
            <a:ext cx="1600200" cy="68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07FF8AA-36C4-478B-A812-C6211AC1F40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438120" y="1901880"/>
          <a:ext cx="6172200" cy="3219480"/>
        </p:xfrm>
        <a:graphic>
          <a:graphicData uri="http://schemas.openxmlformats.org/drawingml/2006/table">
            <a:tbl>
              <a:tblPr/>
              <a:tblGrid>
                <a:gridCol w="699840"/>
                <a:gridCol w="700200"/>
                <a:gridCol w="595440"/>
                <a:gridCol w="598320"/>
                <a:gridCol w="596880"/>
                <a:gridCol w="647640"/>
                <a:gridCol w="546120"/>
                <a:gridCol w="657360"/>
                <a:gridCol w="579240"/>
                <a:gridCol w="551160"/>
              </a:tblGrid>
              <a:tr h="547920"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arget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E gen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T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2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TX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APDH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PR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RPL1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PI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PI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amp;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2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2640">
                <a:tc rowSpan="2"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XCL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TX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30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PR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3000">
                <a:tc rowSpan="3"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ABP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T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30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PR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26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RPL1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1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3000">
                <a:tc rowSpan="3"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UC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T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4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30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2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26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TX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3000">
                <a:tc rowSpan="3"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DCD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T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30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TX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26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APD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42" name=""/>
          <p:cNvGraphicFramePr/>
          <p:nvPr/>
        </p:nvGraphicFramePr>
        <p:xfrm>
          <a:off x="419040" y="5559480"/>
          <a:ext cx="6191280" cy="1920960"/>
        </p:xfrm>
        <a:graphic>
          <a:graphicData uri="http://schemas.openxmlformats.org/drawingml/2006/table">
            <a:tbl>
              <a:tblPr/>
              <a:tblGrid>
                <a:gridCol w="695520"/>
                <a:gridCol w="723600"/>
                <a:gridCol w="581040"/>
                <a:gridCol w="600120"/>
                <a:gridCol w="609840"/>
                <a:gridCol w="618840"/>
                <a:gridCol w="542880"/>
                <a:gridCol w="685800"/>
                <a:gridCol w="571680"/>
                <a:gridCol w="561960"/>
              </a:tblGrid>
              <a:tr h="5475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arget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E gen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T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2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TX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APDH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PR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RPL1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PI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PIA &amp;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2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4680">
                <a:tc rowSpan="2"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XCL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TX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46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PR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4680"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ABP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T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4680"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UC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TX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4680"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DCD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TX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lt;0.0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3" name=""/>
          <p:cNvSpPr/>
          <p:nvPr/>
        </p:nvSpPr>
        <p:spPr>
          <a:xfrm>
            <a:off x="438120" y="5181480"/>
            <a:ext cx="399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200" spc="-1" strike="noStrike">
                <a:solidFill>
                  <a:srgbClr val="000000"/>
                </a:solidFill>
                <a:latin typeface="Times New Roman"/>
              </a:rPr>
              <a:t>(B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428760" y="0"/>
            <a:ext cx="126684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361800" y="399960"/>
            <a:ext cx="6248520" cy="110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</a:rPr>
              <a:t>Table 1: Differences in relative quantities and estimation of error using each of the EC genes and the combination of PPIA and B2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200" spc="-1" strike="noStrike">
                <a:solidFill>
                  <a:srgbClr val="000000"/>
                </a:solidFill>
                <a:latin typeface="Times New Roman"/>
              </a:rPr>
              <a:t>P-value of significant differences in expression (A) and estimation of error (B) of </a:t>
            </a:r>
            <a:r>
              <a:rPr b="0" i="1" lang="en-IE" sz="1200" spc="-1" strike="noStrike">
                <a:solidFill>
                  <a:srgbClr val="000000"/>
                </a:solidFill>
                <a:latin typeface="Times New Roman"/>
              </a:rPr>
              <a:t>CXCL12, FABP1, MUC2</a:t>
            </a:r>
            <a:r>
              <a:rPr b="0" lang="en-IE" sz="1200" spc="-1" strike="noStrike">
                <a:solidFill>
                  <a:srgbClr val="000000"/>
                </a:solidFill>
                <a:latin typeface="Times New Roman"/>
              </a:rPr>
              <a:t> and </a:t>
            </a:r>
            <a:r>
              <a:rPr b="0" i="1" lang="en-IE" sz="1200" spc="-1" strike="noStrike">
                <a:solidFill>
                  <a:srgbClr val="000000"/>
                </a:solidFill>
                <a:latin typeface="Times New Roman"/>
              </a:rPr>
              <a:t>PDCD4</a:t>
            </a:r>
            <a:r>
              <a:rPr b="0" lang="en-IE" sz="1200" spc="-1" strike="noStrike">
                <a:solidFill>
                  <a:srgbClr val="000000"/>
                </a:solidFill>
                <a:latin typeface="Times New Roman"/>
              </a:rPr>
              <a:t> using each of the candidate EC gene compared to the others. (ANOVA Tukey post hoc tests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434880" y="1577880"/>
            <a:ext cx="400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200" spc="-1" strike="noStrike">
                <a:solidFill>
                  <a:srgbClr val="000000"/>
                </a:solidFill>
                <a:latin typeface="Times New Roman"/>
              </a:rPr>
              <a:t>(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49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7-15T12:51:56Z</dcterms:created>
  <dc:creator> </dc:creator>
  <dc:description/>
  <dc:language>en-US</dc:language>
  <cp:lastModifiedBy>Nicola Miller</cp:lastModifiedBy>
  <dcterms:modified xsi:type="dcterms:W3CDTF">2009-08-07T17:37:31Z</dcterms:modified>
  <cp:revision>177</cp:revision>
  <dc:subject/>
  <dc:title>Slide 1</dc:title>
</cp:coreProperties>
</file>